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9" d="100"/>
          <a:sy n="69" d="100"/>
        </p:scale>
        <p:origin x="56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7EE2-6987-4DDC-9253-EE258AD618F7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9B30E-8EB2-40B4-8857-A2138550CD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0706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7EE2-6987-4DDC-9253-EE258AD618F7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9B30E-8EB2-40B4-8857-A2138550CD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402569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7EE2-6987-4DDC-9253-EE258AD618F7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9B30E-8EB2-40B4-8857-A2138550CD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50720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7EE2-6987-4DDC-9253-EE258AD618F7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9B30E-8EB2-40B4-8857-A2138550CD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78867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7EE2-6987-4DDC-9253-EE258AD618F7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9B30E-8EB2-40B4-8857-A2138550CD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59072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7EE2-6987-4DDC-9253-EE258AD618F7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9B30E-8EB2-40B4-8857-A2138550CD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18336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7EE2-6987-4DDC-9253-EE258AD618F7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9B30E-8EB2-40B4-8857-A2138550CD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740046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7EE2-6987-4DDC-9253-EE258AD618F7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9B30E-8EB2-40B4-8857-A2138550CD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73653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7EE2-6987-4DDC-9253-EE258AD618F7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9B30E-8EB2-40B4-8857-A2138550CD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68297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7EE2-6987-4DDC-9253-EE258AD618F7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9B30E-8EB2-40B4-8857-A2138550CD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9734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7EE2-6987-4DDC-9253-EE258AD618F7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99B30E-8EB2-40B4-8857-A2138550CD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92202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C87EE2-6987-4DDC-9253-EE258AD618F7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99B30E-8EB2-40B4-8857-A2138550CD0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462478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6928" y="49933"/>
            <a:ext cx="11499273" cy="6796082"/>
            <a:chOff x="16928" y="49933"/>
            <a:chExt cx="11499273" cy="6796082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13B1B506-1E77-4D83-B694-54AEE7A65EFE}"/>
                </a:ext>
              </a:extLst>
            </p:cNvPr>
            <p:cNvSpPr/>
            <p:nvPr/>
          </p:nvSpPr>
          <p:spPr>
            <a:xfrm>
              <a:off x="16928" y="6199684"/>
              <a:ext cx="11499273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</a:rPr>
                <a:t>Figure </a:t>
              </a:r>
              <a:r>
                <a:rPr lang="en-US" b="1" dirty="0" smtClean="0">
                  <a:latin typeface="Times New Roman" panose="02020603050405020304" pitchFamily="18" charset="0"/>
                </a:rPr>
                <a:t>S8: </a:t>
              </a:r>
              <a:r>
                <a:rPr lang="en-US" dirty="0" smtClean="0">
                  <a:latin typeface="Times New Roman" panose="02020603050405020304" pitchFamily="18" charset="0"/>
                </a:rPr>
                <a:t>Cluster analysis of the </a:t>
              </a:r>
              <a:r>
                <a:rPr lang="en-US" dirty="0">
                  <a:latin typeface="Times New Roman" panose="02020603050405020304" pitchFamily="18" charset="0"/>
                </a:rPr>
                <a:t>six samples sequenced via shotgun metagenomics </a:t>
              </a:r>
              <a:r>
                <a:rPr lang="en-US" dirty="0" smtClean="0">
                  <a:latin typeface="Times New Roman" panose="02020603050405020304" pitchFamily="18" charset="0"/>
                </a:rPr>
                <a:t>for the </a:t>
              </a:r>
              <a:r>
                <a:rPr lang="en-US" dirty="0">
                  <a:latin typeface="Times New Roman" panose="02020603050405020304" pitchFamily="18" charset="0"/>
                </a:rPr>
                <a:t>KEGG </a:t>
              </a:r>
              <a:r>
                <a:rPr lang="en-US" dirty="0" err="1">
                  <a:latin typeface="Times New Roman" panose="02020603050405020304" pitchFamily="18" charset="0"/>
                </a:rPr>
                <a:t>ortholog</a:t>
              </a:r>
              <a:r>
                <a:rPr lang="en-US" dirty="0">
                  <a:latin typeface="Times New Roman" panose="02020603050405020304" pitchFamily="18" charset="0"/>
                </a:rPr>
                <a:t> </a:t>
              </a:r>
              <a:r>
                <a:rPr lang="en-US" dirty="0" smtClean="0">
                  <a:latin typeface="Times New Roman" panose="02020603050405020304" pitchFamily="18" charset="0"/>
                </a:rPr>
                <a:t>functions and taxonomic classifications. Clustering was computed using the Bray-Curtis dissimilarity index. </a:t>
              </a:r>
              <a:endParaRPr lang="he-IL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302598" y="49933"/>
              <a:ext cx="877163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EGG</a:t>
              </a:r>
              <a:endParaRPr lang="he-IL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8185793" y="49933"/>
              <a:ext cx="663643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xa</a:t>
              </a:r>
              <a:endParaRPr lang="he-IL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226579" y="591880"/>
              <a:ext cx="5029200" cy="5807761"/>
              <a:chOff x="226579" y="859736"/>
              <a:chExt cx="5029200" cy="5807761"/>
            </a:xfrm>
          </p:grpSpPr>
          <p:pic>
            <p:nvPicPr>
              <p:cNvPr id="17" name="תמונה 1">
                <a:extLst>
                  <a:ext uri="{FF2B5EF4-FFF2-40B4-BE49-F238E27FC236}">
                    <a16:creationId xmlns:a16="http://schemas.microsoft.com/office/drawing/2014/main" id="{91363C29-9075-4793-8157-24E73EDAC73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6579" y="1400172"/>
                <a:ext cx="5029200" cy="526732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8" name="TextBox 17"/>
              <p:cNvSpPr txBox="1"/>
              <p:nvPr/>
            </p:nvSpPr>
            <p:spPr>
              <a:xfrm rot="16200000">
                <a:off x="707689" y="1328960"/>
                <a:ext cx="1246226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+B--WW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 rot="16200000">
                <a:off x="1487462" y="1554517"/>
                <a:ext cx="795112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+B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 rot="16200000">
                <a:off x="2037468" y="1554517"/>
                <a:ext cx="795112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 rot="16200000">
                <a:off x="2402524" y="1492011"/>
                <a:ext cx="1167135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+FWW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6200000">
                <a:off x="3041630" y="1458919"/>
                <a:ext cx="1015806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+WW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6200000">
                <a:off x="3720411" y="1554516"/>
                <a:ext cx="795112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W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6206113" y="591880"/>
              <a:ext cx="4623002" cy="5553979"/>
              <a:chOff x="6590345" y="1113518"/>
              <a:chExt cx="4623002" cy="5553979"/>
            </a:xfrm>
          </p:grpSpPr>
          <p:pic>
            <p:nvPicPr>
              <p:cNvPr id="10" name="Picture 9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5" r="43065" b="38101"/>
              <a:stretch/>
            </p:blipFill>
            <p:spPr bwMode="auto">
              <a:xfrm>
                <a:off x="6590345" y="1485897"/>
                <a:ext cx="4623002" cy="51816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1" name="TextBox 10"/>
              <p:cNvSpPr txBox="1"/>
              <p:nvPr/>
            </p:nvSpPr>
            <p:spPr>
              <a:xfrm rot="16200000">
                <a:off x="8996372" y="1622288"/>
                <a:ext cx="1167135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+FWW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 rot="16200000">
                <a:off x="7992229" y="1808299"/>
                <a:ext cx="795112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W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6200000">
                <a:off x="8363813" y="1582742"/>
                <a:ext cx="1246226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+B--WW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16200000">
                <a:off x="7280172" y="1697952"/>
                <a:ext cx="1015806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+WW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 rot="16200000">
                <a:off x="9775397" y="1808299"/>
                <a:ext cx="795112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 rot="16200000">
                <a:off x="10405355" y="1889567"/>
                <a:ext cx="795112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+B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78832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Volcan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ren Yanuka-Golub</dc:creator>
  <cp:lastModifiedBy>Keren Yanuka-Golub</cp:lastModifiedBy>
  <cp:revision>1</cp:revision>
  <dcterms:created xsi:type="dcterms:W3CDTF">2020-02-16T11:23:38Z</dcterms:created>
  <dcterms:modified xsi:type="dcterms:W3CDTF">2020-02-16T11:24:20Z</dcterms:modified>
</cp:coreProperties>
</file>